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8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7EFAD-3AAB-4E7D-9EC1-A1A689AA5B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1B2A05-72DE-43C5-BFBF-5C84B87075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4035DB-DC31-445A-B32D-A46EC247F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EA06B8-05DF-4342-84F8-A51127775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7056A7-7CCE-48FB-AC6D-050182DFC1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776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AF7D9-60FB-4486-B0BC-43CCDE2F58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B5284-DACD-48D4-A665-448E3A8CFA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4EB53E-566B-48BB-8FFB-CA4C2915E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50F9AD-AFE9-4EE7-B8DB-929E0D2B5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A8F7D-E813-4D79-92A1-0B4BE11D4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100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BDB169-966F-4EF6-98B0-22D7EBCD93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71B998-EE74-43E3-998E-2C9EB9ACCA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5BBDB6-89F0-4768-888B-27070A7EC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2262C-8A7C-42C6-B9AD-04C80BADD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68EE8A-6D63-4CB1-999B-1550CF7F4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514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C0CAA-136B-4F55-A18F-9394A87E3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F71CF5-104E-4284-960A-495A7197BE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479FDB-EF64-4B20-B400-8B613673F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C1A7C9-CFE0-4612-81D3-A67301ECB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D84C6D-6316-449F-A196-9C4ED1C9B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189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994A4F-2A0B-4B29-B431-1EE4DB339B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05C919-E082-4F4B-8C30-6AEA96E6C6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4656C-F55B-43C5-B0FF-F0AAA06C7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DFD2DB-E86F-4375-A51D-54A904D60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DC636A-FCCD-4006-9185-D449C2A15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382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C967C-BE7E-424C-9B82-CB3FB9FC8E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C30080-C403-4BEF-B2DC-090E5A3F71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9E1571-FDF6-4F54-8DDC-4DB29A64C3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097C32-C15F-49D0-B126-635222DE8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E66292-CD03-4184-94FC-3C72287ED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8B0452-53A0-48BC-868B-0F6FBC9F7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087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E50FB-9623-4F45-8CE0-041B589FFC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D2F244-EEC9-4028-A564-D21B14C43C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CE1A3D-AF57-4E7F-A703-2FE1333E44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013575-12E5-4F10-86DF-93AAE0435E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00EC33D-F1C9-458A-B0BF-05377F86E4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4C9035A-F7BB-4BB9-BCF0-7B8EE60B4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596AAC-1EB5-450F-B90D-099D4AED3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B75906-802E-4CE8-AF3D-33A622C62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269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1CBE2-F63E-483E-B89B-BE67FD8B4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D8EE66-A3F9-43A3-B9D6-67485E492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4A6E35-DCE7-4A28-9A8E-0214159D5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B41DFB-6A0F-459A-8E16-736159202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82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22B08B-3BC1-450B-8E33-895EFE631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04D7844-AFB0-40A4-AF37-EB0E518A3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339C46D-5801-4595-B1C1-F684E4ECF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39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0EEDDE-3C73-4512-8E4A-07F1C158B5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8653C6-919F-4313-86F6-BB1F1329B1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2F2C73-1792-4109-AA4C-5C9B431892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4AA7F4-7932-4F30-800D-D9B1E1ECC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AA647B-6DE6-4F4C-948B-65679E8C0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CA5129-E0C0-4287-B3D8-D9C0B2C9E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42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6A5E89-5CD0-4863-8B9E-C5EC1B295E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29FB43-F694-49B8-BBBB-E6713F14F1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A069B0-3727-48F5-B5F3-3C4D5A926F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8FC3C2-13C2-440E-9CD4-5037F40FE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056E6A-6063-4CFD-84AB-B6FBB6C0A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8C13DE-2E40-4F39-88B4-85A76172B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647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57FBF2-7428-4F86-B9B6-E5ABEA466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B69C74-9CCB-4683-A7BA-C29A1F6334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E5C833-12C4-418B-8491-D7E05A9B56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6D70E0-A31B-4104-AABD-7C00D81DECAA}" type="datetimeFigureOut">
              <a:rPr lang="en-US" smtClean="0"/>
              <a:t>2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1400CA-4E20-45BB-81F7-3416C34C76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8D23A1-1D51-41DE-B39C-93CB23E940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9A3483-3F4F-4060-8969-B9DA0A77F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021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1674730-B657-4861-96C2-46B40CFCD3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616" y="833603"/>
            <a:ext cx="9904767" cy="613375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E25EC0B-F666-44E0-92A9-6462879F8FE8}"/>
              </a:ext>
            </a:extLst>
          </p:cNvPr>
          <p:cNvSpPr txBox="1"/>
          <p:nvPr/>
        </p:nvSpPr>
        <p:spPr>
          <a:xfrm>
            <a:off x="1309291" y="0"/>
            <a:ext cx="10126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S4 Fig. </a:t>
            </a:r>
            <a:r>
              <a:rPr lang="en-US" sz="2400" dirty="0"/>
              <a:t>KRAS cross-exons transcripts in CASE-PE shown by PCR bands in gels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20B15FD-1692-4A8B-A7BB-6E031FEB1009}"/>
              </a:ext>
            </a:extLst>
          </p:cNvPr>
          <p:cNvSpPr txBox="1"/>
          <p:nvPr/>
        </p:nvSpPr>
        <p:spPr>
          <a:xfrm>
            <a:off x="2188232" y="371938"/>
            <a:ext cx="85861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CR of gDNA from RWPE-1 yielded non-specific amplicons without mappable sequence, while </a:t>
            </a:r>
            <a:r>
              <a:rPr lang="en-US" sz="1400" dirty="0" err="1"/>
              <a:t>CAsE</a:t>
            </a:r>
            <a:r>
              <a:rPr lang="en-US" sz="1400" dirty="0"/>
              <a:t>-PE bands of expected size could be sequenced and mapped to KRAS.  See text in Methods section for further details. </a:t>
            </a:r>
          </a:p>
        </p:txBody>
      </p:sp>
    </p:spTree>
    <p:extLst>
      <p:ext uri="{BB962C8B-B14F-4D97-AF65-F5344CB8AC3E}">
        <p14:creationId xmlns:p14="http://schemas.microsoft.com/office/powerpoint/2010/main" val="2576155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rick, Alex (NIH/NIEHS) [E]</dc:creator>
  <cp:lastModifiedBy>Merrick, Alex (NIH/NIEHS) [E]</cp:lastModifiedBy>
  <cp:revision>7</cp:revision>
  <dcterms:created xsi:type="dcterms:W3CDTF">2018-09-14T20:25:20Z</dcterms:created>
  <dcterms:modified xsi:type="dcterms:W3CDTF">2019-02-06T18:19:26Z</dcterms:modified>
</cp:coreProperties>
</file>